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2735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6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6877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0502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9447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138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8387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4781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6287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9403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8412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C0FF2-F4F9-4D33-A71E-603FC6A38363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E412A-C154-456D-B97A-F6FA3C9BA5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5426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05840" y="374073"/>
            <a:ext cx="7724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ummary of balance table of propensity score matchin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/>
        </p:nvGraphicFramePr>
        <p:xfrm>
          <a:off x="931949" y="1519382"/>
          <a:ext cx="4857043" cy="43513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01056">
                  <a:extLst>
                    <a:ext uri="{9D8B030D-6E8A-4147-A177-3AD203B41FA5}">
                      <a16:colId xmlns:a16="http://schemas.microsoft.com/office/drawing/2014/main" val="2354132651"/>
                    </a:ext>
                  </a:extLst>
                </a:gridCol>
                <a:gridCol w="667307">
                  <a:extLst>
                    <a:ext uri="{9D8B030D-6E8A-4147-A177-3AD203B41FA5}">
                      <a16:colId xmlns:a16="http://schemas.microsoft.com/office/drawing/2014/main" val="1631755184"/>
                    </a:ext>
                  </a:extLst>
                </a:gridCol>
                <a:gridCol w="514780">
                  <a:extLst>
                    <a:ext uri="{9D8B030D-6E8A-4147-A177-3AD203B41FA5}">
                      <a16:colId xmlns:a16="http://schemas.microsoft.com/office/drawing/2014/main" val="683473583"/>
                    </a:ext>
                  </a:extLst>
                </a:gridCol>
                <a:gridCol w="514780">
                  <a:extLst>
                    <a:ext uri="{9D8B030D-6E8A-4147-A177-3AD203B41FA5}">
                      <a16:colId xmlns:a16="http://schemas.microsoft.com/office/drawing/2014/main" val="2018222631"/>
                    </a:ext>
                  </a:extLst>
                </a:gridCol>
                <a:gridCol w="514780">
                  <a:extLst>
                    <a:ext uri="{9D8B030D-6E8A-4147-A177-3AD203B41FA5}">
                      <a16:colId xmlns:a16="http://schemas.microsoft.com/office/drawing/2014/main" val="2551449408"/>
                    </a:ext>
                  </a:extLst>
                </a:gridCol>
                <a:gridCol w="514780">
                  <a:extLst>
                    <a:ext uri="{9D8B030D-6E8A-4147-A177-3AD203B41FA5}">
                      <a16:colId xmlns:a16="http://schemas.microsoft.com/office/drawing/2014/main" val="371154174"/>
                    </a:ext>
                  </a:extLst>
                </a:gridCol>
                <a:gridCol w="514780">
                  <a:extLst>
                    <a:ext uri="{9D8B030D-6E8A-4147-A177-3AD203B41FA5}">
                      <a16:colId xmlns:a16="http://schemas.microsoft.com/office/drawing/2014/main" val="3411772443"/>
                    </a:ext>
                  </a:extLst>
                </a:gridCol>
                <a:gridCol w="514780">
                  <a:extLst>
                    <a:ext uri="{9D8B030D-6E8A-4147-A177-3AD203B41FA5}">
                      <a16:colId xmlns:a16="http://schemas.microsoft.com/office/drawing/2014/main" val="3614872004"/>
                    </a:ext>
                  </a:extLst>
                </a:gridCol>
              </a:tblGrid>
              <a:tr h="157140"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Summary of balance for all dat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8284558"/>
                  </a:ext>
                </a:extLst>
              </a:tr>
              <a:tr h="471419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u="none" strike="noStrike" dirty="0">
                          <a:effectLst/>
                        </a:rPr>
                        <a:t>　</a:t>
                      </a:r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Means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ans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Control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D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Control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td.Mean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iff.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eCDF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br>
                        <a:rPr lang="en-US" sz="800" u="none" strike="noStrike" dirty="0">
                          <a:effectLst/>
                        </a:rPr>
                      </a:br>
                      <a:r>
                        <a:rPr lang="en-US" sz="800" u="none" strike="noStrike" dirty="0">
                          <a:effectLst/>
                        </a:rPr>
                        <a:t>M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CDF Mean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CDF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Max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3169080292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distan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92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6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.09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5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49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15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579001355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50.1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9.869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9.93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54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1915797856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Multiplicity)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5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36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0.869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0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0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0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2002383574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Multiplicity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94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743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36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69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0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0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0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4004779644"/>
                  </a:ext>
                </a:extLst>
              </a:tr>
              <a:tr h="2585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Lymphatic_invasion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678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66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37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8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8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6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3482864604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EIC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694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6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2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1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1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25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2044567664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NG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2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548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97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1.25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1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1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20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1277550926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NG)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7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331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470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.612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7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7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540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1278458303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HG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3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65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498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0.95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64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64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2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875343050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HG)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0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45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.515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7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7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546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3805370656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T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6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46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475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712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66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66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33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2705420868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T)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9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169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1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6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139778717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T)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1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039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071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3712274477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N)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6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6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42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-0.263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49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49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99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2447758478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N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59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36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-0.15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3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3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472381811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N)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32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76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-</a:t>
                      </a:r>
                      <a:r>
                        <a:rPr lang="en-US" sz="800" u="none" strike="noStrike" dirty="0" err="1">
                          <a:effectLst/>
                        </a:rPr>
                        <a:t>In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6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6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32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3880771842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ER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11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08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2.049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34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34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668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2346474214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R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5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4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3.130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33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3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67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926930360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HER2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7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17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86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.030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079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7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58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3118882638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Ki_67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9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-In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000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0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175925528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RTx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3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3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2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0.289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049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49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99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847707023"/>
                  </a:ext>
                </a:extLst>
              </a:tr>
              <a:tr h="1571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CTx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7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7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8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1.155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1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1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2848367982"/>
                  </a:ext>
                </a:extLst>
              </a:tr>
              <a:tr h="16428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HTx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03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.846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25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325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65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143" marR="7143" marT="7143" marB="0" anchor="ctr"/>
                </a:tc>
                <a:extLst>
                  <a:ext uri="{0D108BD9-81ED-4DB2-BD59-A6C34878D82A}">
                    <a16:rowId xmlns:a16="http://schemas.microsoft.com/office/drawing/2014/main" val="2891745620"/>
                  </a:ext>
                </a:extLst>
              </a:tr>
            </a:tbl>
          </a:graphicData>
        </a:graphic>
      </p:graphicFrame>
      <p:graphicFrame>
        <p:nvGraphicFramePr>
          <p:cNvPr id="4" name="표 3"/>
          <p:cNvGraphicFramePr>
            <a:graphicFrameLocks noGrp="1"/>
          </p:cNvGraphicFramePr>
          <p:nvPr/>
        </p:nvGraphicFramePr>
        <p:xfrm>
          <a:off x="6265026" y="1519382"/>
          <a:ext cx="5245981" cy="43513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58430">
                  <a:extLst>
                    <a:ext uri="{9D8B030D-6E8A-4147-A177-3AD203B41FA5}">
                      <a16:colId xmlns:a16="http://schemas.microsoft.com/office/drawing/2014/main" val="1362393390"/>
                    </a:ext>
                  </a:extLst>
                </a:gridCol>
                <a:gridCol w="526793">
                  <a:extLst>
                    <a:ext uri="{9D8B030D-6E8A-4147-A177-3AD203B41FA5}">
                      <a16:colId xmlns:a16="http://schemas.microsoft.com/office/drawing/2014/main" val="2957068587"/>
                    </a:ext>
                  </a:extLst>
                </a:gridCol>
                <a:gridCol w="526793">
                  <a:extLst>
                    <a:ext uri="{9D8B030D-6E8A-4147-A177-3AD203B41FA5}">
                      <a16:colId xmlns:a16="http://schemas.microsoft.com/office/drawing/2014/main" val="1658778549"/>
                    </a:ext>
                  </a:extLst>
                </a:gridCol>
                <a:gridCol w="526793">
                  <a:extLst>
                    <a:ext uri="{9D8B030D-6E8A-4147-A177-3AD203B41FA5}">
                      <a16:colId xmlns:a16="http://schemas.microsoft.com/office/drawing/2014/main" val="2313691727"/>
                    </a:ext>
                  </a:extLst>
                </a:gridCol>
                <a:gridCol w="526793">
                  <a:extLst>
                    <a:ext uri="{9D8B030D-6E8A-4147-A177-3AD203B41FA5}">
                      <a16:colId xmlns:a16="http://schemas.microsoft.com/office/drawing/2014/main" val="261051834"/>
                    </a:ext>
                  </a:extLst>
                </a:gridCol>
                <a:gridCol w="526793">
                  <a:extLst>
                    <a:ext uri="{9D8B030D-6E8A-4147-A177-3AD203B41FA5}">
                      <a16:colId xmlns:a16="http://schemas.microsoft.com/office/drawing/2014/main" val="2461189655"/>
                    </a:ext>
                  </a:extLst>
                </a:gridCol>
                <a:gridCol w="526793">
                  <a:extLst>
                    <a:ext uri="{9D8B030D-6E8A-4147-A177-3AD203B41FA5}">
                      <a16:colId xmlns:a16="http://schemas.microsoft.com/office/drawing/2014/main" val="3241848259"/>
                    </a:ext>
                  </a:extLst>
                </a:gridCol>
                <a:gridCol w="526793">
                  <a:extLst>
                    <a:ext uri="{9D8B030D-6E8A-4147-A177-3AD203B41FA5}">
                      <a16:colId xmlns:a16="http://schemas.microsoft.com/office/drawing/2014/main" val="1759995488"/>
                    </a:ext>
                  </a:extLst>
                </a:gridCol>
              </a:tblGrid>
              <a:tr h="160890"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ummary of balance for matched data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0942140"/>
                  </a:ext>
                </a:extLst>
              </a:tr>
              <a:tr h="482669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u="none" strike="noStrike">
                          <a:effectLst/>
                        </a:rPr>
                        <a:t>　</a:t>
                      </a:r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ans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Treated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eans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Control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D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Control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td.Mean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Diff.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CDF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Med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CDF Mean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CDF </a:t>
                      </a:r>
                      <a:br>
                        <a:rPr lang="en-US" sz="800" u="none" strike="noStrike">
                          <a:effectLst/>
                        </a:rPr>
                      </a:br>
                      <a:r>
                        <a:rPr lang="en-US" sz="800" u="none" strike="noStrike">
                          <a:effectLst/>
                        </a:rPr>
                        <a:t>Max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1216983200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distan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8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81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52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1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4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35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3531938256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50.1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9.87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0.867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6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6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87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1114918562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Multiplicity)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58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64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4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0.02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2849061874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Multiplicity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4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35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4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1111226959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Lymphatic_invasion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3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20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8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1421592931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EIC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1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1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73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0.007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0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0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1787477300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NG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3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39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46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0.018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2504526099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NG)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6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58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49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4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4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2781408360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HG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4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45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5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0.012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2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2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196664024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HG)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4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35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71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2702231080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T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708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66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471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1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1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4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4098785852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T)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35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3759255622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T)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2987722124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N)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6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6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3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3659468247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N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3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68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3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1557728027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N)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2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4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-In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2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710920470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ER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6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3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3266340300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PR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6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79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0.077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8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8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6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943865927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HER2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981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35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-0.04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6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850132367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Ki_67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3832355906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RTx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4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13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4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7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1180769797"/>
                  </a:ext>
                </a:extLst>
              </a:tr>
              <a:tr h="1608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ctor(CTx)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6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218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6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8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8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16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2395019457"/>
                  </a:ext>
                </a:extLst>
              </a:tr>
              <a:tr h="1682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factor(</a:t>
                      </a:r>
                      <a:r>
                        <a:rPr lang="en-US" sz="800" u="none" strike="noStrike" dirty="0" err="1">
                          <a:effectLst/>
                        </a:rPr>
                        <a:t>HTx</a:t>
                      </a:r>
                      <a:r>
                        <a:rPr lang="en-US" sz="800" u="none" strike="noStrike" dirty="0">
                          <a:effectLst/>
                        </a:rPr>
                        <a:t>)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84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365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23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4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0.004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</a:rPr>
                        <a:t>0.00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313" marR="7313" marT="7313" marB="0" anchor="ctr"/>
                </a:tc>
                <a:extLst>
                  <a:ext uri="{0D108BD9-81ED-4DB2-BD59-A6C34878D82A}">
                    <a16:rowId xmlns:a16="http://schemas.microsoft.com/office/drawing/2014/main" val="2383673895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495489" y="1150050"/>
            <a:ext cx="1729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 matchin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093567" y="1150050"/>
            <a:ext cx="1588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matchin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514162" y="6032307"/>
            <a:ext cx="53062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>
                <a:latin typeface="맑은 고딕" panose="020B0503020000020004" pitchFamily="50" charset="-127"/>
                <a:ea typeface="맑은 고딕" panose="020B0503020000020004" pitchFamily="50" charset="-127"/>
                <a:cs typeface="Times New Roman" panose="02020603050405020304" pitchFamily="18" charset="0"/>
              </a:rPr>
              <a:t>† </a:t>
            </a:r>
            <a:r>
              <a:rPr lang="en-US" altLang="ko-K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variables are well balanced because all standardized mean differences are lower than 0.1, </a:t>
            </a:r>
          </a:p>
          <a:p>
            <a:r>
              <a:rPr lang="en-US" altLang="ko-K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value commonly considered as threshold for balance checking</a:t>
            </a:r>
            <a:endParaRPr lang="ko-KR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301940" y="1695801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+mj-lt"/>
                <a:cs typeface="Times New Roman" panose="02020603050405020304" pitchFamily="18" charset="0"/>
              </a:rPr>
              <a:t>†</a:t>
            </a:r>
            <a:endParaRPr lang="ko-KR" altLang="en-US" sz="1200" dirty="0">
              <a:latin typeface="+mj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8067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654</Words>
  <Application>Microsoft Office PowerPoint</Application>
  <PresentationFormat>Widescreen</PresentationFormat>
  <Paragraphs>39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ch</dc:creator>
  <cp:lastModifiedBy>MDPI</cp:lastModifiedBy>
  <cp:revision>5</cp:revision>
  <dcterms:created xsi:type="dcterms:W3CDTF">2023-02-07T22:25:57Z</dcterms:created>
  <dcterms:modified xsi:type="dcterms:W3CDTF">2023-03-02T03:50:24Z</dcterms:modified>
</cp:coreProperties>
</file>